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511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15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ycheng\Desktop\Computer\UnderGradWork_2018\2019_03_20_CFU_CD8-Tcells_Coculture\CFU_CD8_2019_03_2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ycheng\Desktop\Computer\UnderGradWork_2018\2018_06_13_CFU_BMMs_M.avium\CFU_BMMs_M.avium_2018_06_1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ycheng\Desktop\Computer\UnderGradWork_2018\2018_06_13_CFU_BMMs_M.avium\CFU_RIG-I_M.avium_2018_06_13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ycheng\Desktop\Computer\UnderGradWork_2018\2019_02_02_CFU_Coculture_GenR\CFU_NaiveTcells_2019_02_0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268670220570255"/>
          <c:y val="4.5086705202312151E-2"/>
          <c:w val="0.86178534748373847"/>
          <c:h val="0.8260579855263756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6</c:f>
              <c:strCache>
                <c:ptCount val="1"/>
                <c:pt idx="0">
                  <c:v>WT BMMs 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26:$H$26</c:f>
                <c:numCache>
                  <c:formatCode>General</c:formatCode>
                  <c:ptCount val="3"/>
                  <c:pt idx="0">
                    <c:v>9.5773058929878807E-2</c:v>
                  </c:pt>
                  <c:pt idx="1">
                    <c:v>7.7873662872497029E-2</c:v>
                  </c:pt>
                  <c:pt idx="2">
                    <c:v>5.8768577287692393E-2</c:v>
                  </c:pt>
                </c:numCache>
              </c:numRef>
            </c:plus>
            <c:minus>
              <c:numRef>
                <c:f>Sheet1!$F$26:$H$26</c:f>
                <c:numCache>
                  <c:formatCode>General</c:formatCode>
                  <c:ptCount val="3"/>
                  <c:pt idx="0">
                    <c:v>9.5773058929878807E-2</c:v>
                  </c:pt>
                  <c:pt idx="1">
                    <c:v>7.7873662872497029E-2</c:v>
                  </c:pt>
                  <c:pt idx="2">
                    <c:v>5.87685772876923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25:$D$25</c:f>
              <c:numCache>
                <c:formatCode>General</c:formatCode>
                <c:ptCount val="3"/>
                <c:pt idx="0">
                  <c:v>1</c:v>
                </c:pt>
                <c:pt idx="1">
                  <c:v>24</c:v>
                </c:pt>
                <c:pt idx="2">
                  <c:v>72</c:v>
                </c:pt>
              </c:numCache>
            </c:numRef>
          </c:cat>
          <c:val>
            <c:numRef>
              <c:f>Sheet1!$B$26:$D$26</c:f>
              <c:numCache>
                <c:formatCode>General</c:formatCode>
                <c:ptCount val="3"/>
                <c:pt idx="0">
                  <c:v>4.7803618747240391</c:v>
                </c:pt>
                <c:pt idx="1">
                  <c:v>4.8762506736182525</c:v>
                </c:pt>
                <c:pt idx="2">
                  <c:v>5.20534680357841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447-1147-8B21-2721FA4F0CD0}"/>
            </c:ext>
          </c:extLst>
        </c:ser>
        <c:ser>
          <c:idx val="1"/>
          <c:order val="1"/>
          <c:tx>
            <c:strRef>
              <c:f>Sheet1!$A$27</c:f>
              <c:strCache>
                <c:ptCount val="1"/>
                <c:pt idx="0">
                  <c:v>WT BMMs + WT CD8 T Cells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27:$H$27</c:f>
                <c:numCache>
                  <c:formatCode>General</c:formatCode>
                  <c:ptCount val="3"/>
                  <c:pt idx="0">
                    <c:v>9.0585502863154171E-2</c:v>
                  </c:pt>
                  <c:pt idx="1">
                    <c:v>9.8142461463706102E-2</c:v>
                  </c:pt>
                  <c:pt idx="2">
                    <c:v>0.12911347700503165</c:v>
                  </c:pt>
                </c:numCache>
              </c:numRef>
            </c:plus>
            <c:minus>
              <c:numRef>
                <c:f>Sheet1!$F$27:$H$27</c:f>
                <c:numCache>
                  <c:formatCode>General</c:formatCode>
                  <c:ptCount val="3"/>
                  <c:pt idx="0">
                    <c:v>9.0585502863154171E-2</c:v>
                  </c:pt>
                  <c:pt idx="1">
                    <c:v>9.8142461463706102E-2</c:v>
                  </c:pt>
                  <c:pt idx="2">
                    <c:v>0.129113477005031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25:$D$25</c:f>
              <c:numCache>
                <c:formatCode>General</c:formatCode>
                <c:ptCount val="3"/>
                <c:pt idx="0">
                  <c:v>1</c:v>
                </c:pt>
                <c:pt idx="1">
                  <c:v>24</c:v>
                </c:pt>
                <c:pt idx="2">
                  <c:v>72</c:v>
                </c:pt>
              </c:numCache>
            </c:numRef>
          </c:cat>
          <c:val>
            <c:numRef>
              <c:f>Sheet1!$B$27:$D$27</c:f>
              <c:numCache>
                <c:formatCode>General</c:formatCode>
                <c:ptCount val="3"/>
                <c:pt idx="0">
                  <c:v>4.7289604409430313</c:v>
                </c:pt>
                <c:pt idx="1">
                  <c:v>4.7216357793224253</c:v>
                </c:pt>
                <c:pt idx="2">
                  <c:v>4.934760186456835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447-1147-8B21-2721FA4F0CD0}"/>
            </c:ext>
          </c:extLst>
        </c:ser>
        <c:ser>
          <c:idx val="2"/>
          <c:order val="2"/>
          <c:tx>
            <c:strRef>
              <c:f>Sheet1!$A$28</c:f>
              <c:strCache>
                <c:ptCount val="1"/>
                <c:pt idx="0">
                  <c:v>MAVS-/- BMMs 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28:$H$28</c:f>
                <c:numCache>
                  <c:formatCode>General</c:formatCode>
                  <c:ptCount val="3"/>
                  <c:pt idx="0">
                    <c:v>5.2763205449917118E-2</c:v>
                  </c:pt>
                  <c:pt idx="1">
                    <c:v>0.11484378164211002</c:v>
                  </c:pt>
                  <c:pt idx="2">
                    <c:v>8.8574600042188825E-2</c:v>
                  </c:pt>
                </c:numCache>
              </c:numRef>
            </c:plus>
            <c:minus>
              <c:numRef>
                <c:f>Sheet1!$F$28:$H$28</c:f>
                <c:numCache>
                  <c:formatCode>General</c:formatCode>
                  <c:ptCount val="3"/>
                  <c:pt idx="0">
                    <c:v>5.2763205449917118E-2</c:v>
                  </c:pt>
                  <c:pt idx="1">
                    <c:v>0.11484378164211002</c:v>
                  </c:pt>
                  <c:pt idx="2">
                    <c:v>8.857460004218882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25:$D$25</c:f>
              <c:numCache>
                <c:formatCode>General</c:formatCode>
                <c:ptCount val="3"/>
                <c:pt idx="0">
                  <c:v>1</c:v>
                </c:pt>
                <c:pt idx="1">
                  <c:v>24</c:v>
                </c:pt>
                <c:pt idx="2">
                  <c:v>72</c:v>
                </c:pt>
              </c:numCache>
            </c:numRef>
          </c:cat>
          <c:val>
            <c:numRef>
              <c:f>Sheet1!$B$28:$D$28</c:f>
              <c:numCache>
                <c:formatCode>General</c:formatCode>
                <c:ptCount val="3"/>
                <c:pt idx="0">
                  <c:v>4.7511909067418037</c:v>
                </c:pt>
                <c:pt idx="1">
                  <c:v>4.9793727147824116</c:v>
                </c:pt>
                <c:pt idx="2">
                  <c:v>5.47247650762136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447-1147-8B21-2721FA4F0CD0}"/>
            </c:ext>
          </c:extLst>
        </c:ser>
        <c:ser>
          <c:idx val="3"/>
          <c:order val="3"/>
          <c:tx>
            <c:strRef>
              <c:f>Sheet1!$A$29</c:f>
              <c:strCache>
                <c:ptCount val="1"/>
                <c:pt idx="0">
                  <c:v>MAVS-/- BMMs + WT CD8 T Cells</c:v>
                </c:pt>
              </c:strCache>
            </c:strRef>
          </c:tx>
          <c:spPr>
            <a:solidFill>
              <a:schemeClr val="accent4"/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29:$H$29</c:f>
                <c:numCache>
                  <c:formatCode>General</c:formatCode>
                  <c:ptCount val="3"/>
                  <c:pt idx="0">
                    <c:v>0.11677194414706933</c:v>
                  </c:pt>
                  <c:pt idx="1">
                    <c:v>9.4002138867624707E-2</c:v>
                  </c:pt>
                  <c:pt idx="2">
                    <c:v>0.11590207508410279</c:v>
                  </c:pt>
                </c:numCache>
              </c:numRef>
            </c:plus>
            <c:minus>
              <c:numRef>
                <c:f>Sheet1!$F$29:$H$29</c:f>
                <c:numCache>
                  <c:formatCode>General</c:formatCode>
                  <c:ptCount val="3"/>
                  <c:pt idx="0">
                    <c:v>0.11677194414706933</c:v>
                  </c:pt>
                  <c:pt idx="1">
                    <c:v>9.4002138867624707E-2</c:v>
                  </c:pt>
                  <c:pt idx="2">
                    <c:v>0.115902075084102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25:$D$25</c:f>
              <c:numCache>
                <c:formatCode>General</c:formatCode>
                <c:ptCount val="3"/>
                <c:pt idx="0">
                  <c:v>1</c:v>
                </c:pt>
                <c:pt idx="1">
                  <c:v>24</c:v>
                </c:pt>
                <c:pt idx="2">
                  <c:v>72</c:v>
                </c:pt>
              </c:numCache>
            </c:numRef>
          </c:cat>
          <c:val>
            <c:numRef>
              <c:f>Sheet1!$B$29:$D$29</c:f>
              <c:numCache>
                <c:formatCode>General</c:formatCode>
                <c:ptCount val="3"/>
                <c:pt idx="0">
                  <c:v>4.7315869607670278</c:v>
                </c:pt>
                <c:pt idx="1">
                  <c:v>4.8250979057941912</c:v>
                </c:pt>
                <c:pt idx="2">
                  <c:v>5.18368744763229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4447-1147-8B21-2721FA4F0C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33980008"/>
        <c:axId val="633973736"/>
      </c:barChart>
      <c:catAx>
        <c:axId val="633980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33973736"/>
        <c:crosses val="autoZero"/>
        <c:auto val="1"/>
        <c:lblAlgn val="ctr"/>
        <c:lblOffset val="100"/>
        <c:noMultiLvlLbl val="0"/>
      </c:catAx>
      <c:valAx>
        <c:axId val="633973736"/>
        <c:scaling>
          <c:orientation val="minMax"/>
          <c:max val="7"/>
          <c:min val="3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3398000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1841406422135377"/>
          <c:y val="4.7094626864989497E-2"/>
          <c:w val="0.78055088838802211"/>
          <c:h val="0.2046776811858055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883139607549055"/>
          <c:y val="5.3921568627450983E-2"/>
          <c:w val="0.80296754572345119"/>
          <c:h val="0.8133657557511193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0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00FDFF"/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21:$G$24</c:f>
                <c:numCache>
                  <c:formatCode>General</c:formatCode>
                  <c:ptCount val="4"/>
                  <c:pt idx="0">
                    <c:v>8.3812353144372104E-2</c:v>
                  </c:pt>
                  <c:pt idx="1">
                    <c:v>0.10405393220670085</c:v>
                  </c:pt>
                  <c:pt idx="2">
                    <c:v>6.7816651710066927E-2</c:v>
                  </c:pt>
                </c:numCache>
              </c:numRef>
            </c:plus>
            <c:minus>
              <c:numRef>
                <c:f>Sheet1!$G$21:$G$24</c:f>
                <c:numCache>
                  <c:formatCode>General</c:formatCode>
                  <c:ptCount val="4"/>
                  <c:pt idx="0">
                    <c:v>8.3812353144372104E-2</c:v>
                  </c:pt>
                  <c:pt idx="1">
                    <c:v>0.10405393220670085</c:v>
                  </c:pt>
                  <c:pt idx="2">
                    <c:v>6.781665171006692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21:$A$23</c:f>
              <c:numCache>
                <c:formatCode>General</c:formatCode>
                <c:ptCount val="3"/>
                <c:pt idx="0">
                  <c:v>1</c:v>
                </c:pt>
                <c:pt idx="1">
                  <c:v>24</c:v>
                </c:pt>
                <c:pt idx="2">
                  <c:v>72</c:v>
                </c:pt>
              </c:numCache>
            </c:numRef>
          </c:cat>
          <c:val>
            <c:numRef>
              <c:f>Sheet1!$B$21:$B$23</c:f>
              <c:numCache>
                <c:formatCode>General</c:formatCode>
                <c:ptCount val="3"/>
                <c:pt idx="0">
                  <c:v>4.1644969088057904</c:v>
                </c:pt>
                <c:pt idx="1">
                  <c:v>4.4537124535880963</c:v>
                </c:pt>
                <c:pt idx="2">
                  <c:v>4.854275679264987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757-FE45-8A44-15D0D152DFCA}"/>
            </c:ext>
          </c:extLst>
        </c:ser>
        <c:ser>
          <c:idx val="1"/>
          <c:order val="1"/>
          <c:tx>
            <c:strRef>
              <c:f>Sheet1!$C$20</c:f>
              <c:strCache>
                <c:ptCount val="1"/>
                <c:pt idx="0">
                  <c:v>Mavs-/-</c:v>
                </c:pt>
              </c:strCache>
            </c:strRef>
          </c:tx>
          <c:spPr>
            <a:solidFill>
              <a:srgbClr val="FF7E79"/>
            </a:solidFill>
            <a:ln cap="rnd"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H$21:$H$24</c:f>
                <c:numCache>
                  <c:formatCode>General</c:formatCode>
                  <c:ptCount val="4"/>
                  <c:pt idx="0">
                    <c:v>0.12234680662066316</c:v>
                  </c:pt>
                  <c:pt idx="1">
                    <c:v>7.8924254507486621E-2</c:v>
                  </c:pt>
                  <c:pt idx="2">
                    <c:v>7.4972383390920883E-2</c:v>
                  </c:pt>
                </c:numCache>
              </c:numRef>
            </c:plus>
            <c:minus>
              <c:numRef>
                <c:f>Sheet1!$H$21:$H$24</c:f>
                <c:numCache>
                  <c:formatCode>General</c:formatCode>
                  <c:ptCount val="4"/>
                  <c:pt idx="0">
                    <c:v>0.12234680662066316</c:v>
                  </c:pt>
                  <c:pt idx="1">
                    <c:v>7.8924254507486621E-2</c:v>
                  </c:pt>
                  <c:pt idx="2">
                    <c:v>7.497238339092088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21:$A$23</c:f>
              <c:numCache>
                <c:formatCode>General</c:formatCode>
                <c:ptCount val="3"/>
                <c:pt idx="0">
                  <c:v>1</c:v>
                </c:pt>
                <c:pt idx="1">
                  <c:v>24</c:v>
                </c:pt>
                <c:pt idx="2">
                  <c:v>72</c:v>
                </c:pt>
              </c:numCache>
            </c:numRef>
          </c:cat>
          <c:val>
            <c:numRef>
              <c:f>Sheet1!$C$21:$C$23</c:f>
              <c:numCache>
                <c:formatCode>General</c:formatCode>
                <c:ptCount val="3"/>
                <c:pt idx="0">
                  <c:v>4.2102260335728401</c:v>
                </c:pt>
                <c:pt idx="1">
                  <c:v>4.5368201777847981</c:v>
                </c:pt>
                <c:pt idx="2">
                  <c:v>5.09992727791497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757-FE45-8A44-15D0D152DF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33979224"/>
        <c:axId val="633987064"/>
      </c:barChart>
      <c:catAx>
        <c:axId val="6339792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33987064"/>
        <c:crosses val="autoZero"/>
        <c:auto val="1"/>
        <c:lblAlgn val="ctr"/>
        <c:lblOffset val="100"/>
        <c:noMultiLvlLbl val="0"/>
      </c:catAx>
      <c:valAx>
        <c:axId val="633987064"/>
        <c:scaling>
          <c:orientation val="minMax"/>
          <c:max val="6.5"/>
          <c:min val="3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3397922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7913161945256018"/>
          <c:y val="5.6156327596526022E-2"/>
          <c:w val="0.46530592143298649"/>
          <c:h val="0.1401533276468262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 sz="8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0402234996699032E-2"/>
          <c:y val="7.9110967147146397E-2"/>
          <c:w val="0.87460798995217626"/>
          <c:h val="0.821113510929998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72F9E8"/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23:$I$26</c:f>
                <c:numCache>
                  <c:formatCode>General</c:formatCode>
                  <c:ptCount val="4"/>
                  <c:pt idx="0">
                    <c:v>9.4215470316859395E-2</c:v>
                  </c:pt>
                  <c:pt idx="1">
                    <c:v>8.1373404530655169E-2</c:v>
                  </c:pt>
                  <c:pt idx="2">
                    <c:v>6.2839171514072492E-2</c:v>
                  </c:pt>
                </c:numCache>
              </c:numRef>
            </c:plus>
            <c:minus>
              <c:numRef>
                <c:f>Sheet1!$I$23:$I$26</c:f>
                <c:numCache>
                  <c:formatCode>General</c:formatCode>
                  <c:ptCount val="4"/>
                  <c:pt idx="0">
                    <c:v>9.4215470316859395E-2</c:v>
                  </c:pt>
                  <c:pt idx="1">
                    <c:v>8.1373404530655169E-2</c:v>
                  </c:pt>
                  <c:pt idx="2">
                    <c:v>6.283917151407249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23:$A$25</c:f>
              <c:numCache>
                <c:formatCode>General</c:formatCode>
                <c:ptCount val="3"/>
                <c:pt idx="0">
                  <c:v>1</c:v>
                </c:pt>
                <c:pt idx="1">
                  <c:v>24</c:v>
                </c:pt>
                <c:pt idx="2">
                  <c:v>72</c:v>
                </c:pt>
              </c:numCache>
            </c:numRef>
          </c:cat>
          <c:val>
            <c:numRef>
              <c:f>Sheet1!$B$23:$B$25</c:f>
              <c:numCache>
                <c:formatCode>General</c:formatCode>
                <c:ptCount val="3"/>
                <c:pt idx="0">
                  <c:v>4.2043164445860297</c:v>
                </c:pt>
                <c:pt idx="1">
                  <c:v>4.396485073537888</c:v>
                </c:pt>
                <c:pt idx="2">
                  <c:v>4.748658565003741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703-A349-8D94-26C3CA794C02}"/>
            </c:ext>
          </c:extLst>
        </c:ser>
        <c:ser>
          <c:idx val="1"/>
          <c:order val="1"/>
          <c:tx>
            <c:strRef>
              <c:f>Sheet1!$C$22</c:f>
              <c:strCache>
                <c:ptCount val="1"/>
                <c:pt idx="0">
                  <c:v>RIG-I</c:v>
                </c:pt>
              </c:strCache>
            </c:strRef>
          </c:tx>
          <c:spPr>
            <a:solidFill>
              <a:srgbClr val="E836DA"/>
            </a:solidFill>
            <a:ln cap="rnd"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J$23:$J$26</c:f>
                <c:numCache>
                  <c:formatCode>General</c:formatCode>
                  <c:ptCount val="4"/>
                  <c:pt idx="0">
                    <c:v>0.11685075541647055</c:v>
                  </c:pt>
                  <c:pt idx="1">
                    <c:v>6.9308712298497721E-2</c:v>
                  </c:pt>
                  <c:pt idx="2">
                    <c:v>6.6415569919539494E-2</c:v>
                  </c:pt>
                </c:numCache>
              </c:numRef>
            </c:plus>
            <c:minus>
              <c:numRef>
                <c:f>Sheet1!$J$23:$J$26</c:f>
                <c:numCache>
                  <c:formatCode>General</c:formatCode>
                  <c:ptCount val="4"/>
                  <c:pt idx="0">
                    <c:v>0.11685075541647055</c:v>
                  </c:pt>
                  <c:pt idx="1">
                    <c:v>6.9308712298497721E-2</c:v>
                  </c:pt>
                  <c:pt idx="2">
                    <c:v>6.641556991953949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23:$A$25</c:f>
              <c:numCache>
                <c:formatCode>General</c:formatCode>
                <c:ptCount val="3"/>
                <c:pt idx="0">
                  <c:v>1</c:v>
                </c:pt>
                <c:pt idx="1">
                  <c:v>24</c:v>
                </c:pt>
                <c:pt idx="2">
                  <c:v>72</c:v>
                </c:pt>
              </c:numCache>
            </c:numRef>
          </c:cat>
          <c:val>
            <c:numRef>
              <c:f>Sheet1!$C$23:$C$25</c:f>
              <c:numCache>
                <c:formatCode>General</c:formatCode>
                <c:ptCount val="3"/>
                <c:pt idx="0">
                  <c:v>4.1529284474944363</c:v>
                </c:pt>
                <c:pt idx="1">
                  <c:v>4.4550633015918288</c:v>
                </c:pt>
                <c:pt idx="2">
                  <c:v>4.941674245097032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703-A349-8D94-26C3CA794C02}"/>
            </c:ext>
          </c:extLst>
        </c:ser>
        <c:ser>
          <c:idx val="2"/>
          <c:order val="2"/>
          <c:tx>
            <c:strRef>
              <c:f>Sheet1!$D$22</c:f>
              <c:strCache>
                <c:ptCount val="1"/>
                <c:pt idx="0">
                  <c:v>TBK1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K$23:$K$25</c:f>
                <c:numCache>
                  <c:formatCode>General</c:formatCode>
                  <c:ptCount val="3"/>
                  <c:pt idx="0">
                    <c:v>8.5752957135428104E-2</c:v>
                  </c:pt>
                  <c:pt idx="1">
                    <c:v>7.2846087904757287E-2</c:v>
                  </c:pt>
                  <c:pt idx="2">
                    <c:v>3.5889995138859217E-2</c:v>
                  </c:pt>
                </c:numCache>
              </c:numRef>
            </c:plus>
            <c:minus>
              <c:numRef>
                <c:f>Sheet1!$K$23:$K$25</c:f>
                <c:numCache>
                  <c:formatCode>General</c:formatCode>
                  <c:ptCount val="3"/>
                  <c:pt idx="0">
                    <c:v>8.5752957135428104E-2</c:v>
                  </c:pt>
                  <c:pt idx="1">
                    <c:v>7.2846087904757287E-2</c:v>
                  </c:pt>
                  <c:pt idx="2">
                    <c:v>3.588999513885921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23:$A$25</c:f>
              <c:numCache>
                <c:formatCode>General</c:formatCode>
                <c:ptCount val="3"/>
                <c:pt idx="0">
                  <c:v>1</c:v>
                </c:pt>
                <c:pt idx="1">
                  <c:v>24</c:v>
                </c:pt>
                <c:pt idx="2">
                  <c:v>72</c:v>
                </c:pt>
              </c:numCache>
            </c:numRef>
          </c:cat>
          <c:val>
            <c:numRef>
              <c:f>Sheet1!$D$23:$D$25</c:f>
              <c:numCache>
                <c:formatCode>General</c:formatCode>
                <c:ptCount val="3"/>
                <c:pt idx="0">
                  <c:v>4.2108616015864682</c:v>
                </c:pt>
                <c:pt idx="1">
                  <c:v>4.4320416903036248</c:v>
                </c:pt>
                <c:pt idx="2">
                  <c:v>5.0270543309619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703-A349-8D94-26C3CA794C02}"/>
            </c:ext>
          </c:extLst>
        </c:ser>
        <c:ser>
          <c:idx val="3"/>
          <c:order val="3"/>
          <c:tx>
            <c:strRef>
              <c:f>Sheet1!$E$22</c:f>
              <c:strCache>
                <c:ptCount val="1"/>
                <c:pt idx="0">
                  <c:v>IRF3</c:v>
                </c:pt>
              </c:strCache>
            </c:strRef>
          </c:tx>
          <c:spPr>
            <a:solidFill>
              <a:srgbClr val="FF7E79"/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L$23:$L$25</c:f>
                <c:numCache>
                  <c:formatCode>General</c:formatCode>
                  <c:ptCount val="3"/>
                  <c:pt idx="0">
                    <c:v>0.13650460106928075</c:v>
                  </c:pt>
                  <c:pt idx="1">
                    <c:v>8.1318767601833319E-2</c:v>
                  </c:pt>
                  <c:pt idx="2">
                    <c:v>5.4534887061817042E-2</c:v>
                  </c:pt>
                </c:numCache>
              </c:numRef>
            </c:plus>
            <c:minus>
              <c:numRef>
                <c:f>Sheet1!$L$23:$L$25</c:f>
                <c:numCache>
                  <c:formatCode>General</c:formatCode>
                  <c:ptCount val="3"/>
                  <c:pt idx="0">
                    <c:v>0.13650460106928075</c:v>
                  </c:pt>
                  <c:pt idx="1">
                    <c:v>8.1318767601833319E-2</c:v>
                  </c:pt>
                  <c:pt idx="2">
                    <c:v>5.453488706181704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23:$A$25</c:f>
              <c:numCache>
                <c:formatCode>General</c:formatCode>
                <c:ptCount val="3"/>
                <c:pt idx="0">
                  <c:v>1</c:v>
                </c:pt>
                <c:pt idx="1">
                  <c:v>24</c:v>
                </c:pt>
                <c:pt idx="2">
                  <c:v>72</c:v>
                </c:pt>
              </c:numCache>
            </c:numRef>
          </c:cat>
          <c:val>
            <c:numRef>
              <c:f>Sheet1!$E$23:$E$25</c:f>
              <c:numCache>
                <c:formatCode>General</c:formatCode>
                <c:ptCount val="3"/>
                <c:pt idx="0">
                  <c:v>4.1371013234100067</c:v>
                </c:pt>
                <c:pt idx="1">
                  <c:v>4.5038915051158606</c:v>
                </c:pt>
                <c:pt idx="2">
                  <c:v>4.96188929257387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8703-A349-8D94-26C3CA794C02}"/>
            </c:ext>
          </c:extLst>
        </c:ser>
        <c:ser>
          <c:idx val="4"/>
          <c:order val="4"/>
          <c:tx>
            <c:strRef>
              <c:f>Sheet1!$F$22</c:f>
              <c:strCache>
                <c:ptCount val="1"/>
                <c:pt idx="0">
                  <c:v>IRF7</c:v>
                </c:pt>
              </c:strCache>
            </c:strRef>
          </c:tx>
          <c:spPr>
            <a:solidFill>
              <a:srgbClr val="68B1FF"/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M$23:$M$25</c:f>
                <c:numCache>
                  <c:formatCode>General</c:formatCode>
                  <c:ptCount val="3"/>
                  <c:pt idx="0">
                    <c:v>0.13288501073703216</c:v>
                  </c:pt>
                  <c:pt idx="1">
                    <c:v>0.10683636792576039</c:v>
                  </c:pt>
                  <c:pt idx="2">
                    <c:v>5.7041198125287955E-2</c:v>
                  </c:pt>
                </c:numCache>
              </c:numRef>
            </c:plus>
            <c:minus>
              <c:numRef>
                <c:f>Sheet1!$M$23:$M$25</c:f>
                <c:numCache>
                  <c:formatCode>General</c:formatCode>
                  <c:ptCount val="3"/>
                  <c:pt idx="0">
                    <c:v>0.13288501073703216</c:v>
                  </c:pt>
                  <c:pt idx="1">
                    <c:v>0.10683636792576039</c:v>
                  </c:pt>
                  <c:pt idx="2">
                    <c:v>5.704119812528795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23:$A$25</c:f>
              <c:numCache>
                <c:formatCode>General</c:formatCode>
                <c:ptCount val="3"/>
                <c:pt idx="0">
                  <c:v>1</c:v>
                </c:pt>
                <c:pt idx="1">
                  <c:v>24</c:v>
                </c:pt>
                <c:pt idx="2">
                  <c:v>72</c:v>
                </c:pt>
              </c:numCache>
            </c:numRef>
          </c:cat>
          <c:val>
            <c:numRef>
              <c:f>Sheet1!$F$23:$F$25</c:f>
              <c:numCache>
                <c:formatCode>General</c:formatCode>
                <c:ptCount val="3"/>
                <c:pt idx="0">
                  <c:v>4.2028005686691223</c:v>
                </c:pt>
                <c:pt idx="1">
                  <c:v>4.4805210675269338</c:v>
                </c:pt>
                <c:pt idx="2">
                  <c:v>5.0406027386122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8703-A349-8D94-26C3CA794C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33978048"/>
        <c:axId val="633972168"/>
      </c:barChart>
      <c:catAx>
        <c:axId val="6339780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33972168"/>
        <c:crosses val="autoZero"/>
        <c:auto val="1"/>
        <c:lblAlgn val="ctr"/>
        <c:lblOffset val="100"/>
        <c:noMultiLvlLbl val="0"/>
      </c:catAx>
      <c:valAx>
        <c:axId val="633972168"/>
        <c:scaling>
          <c:orientation val="minMax"/>
          <c:max val="6.5"/>
          <c:min val="3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3397804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0335737972873152"/>
          <c:y val="3.0732683838249033E-2"/>
          <c:w val="0.88466657236707691"/>
          <c:h val="0.1138776191111704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 sz="8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268670220570255"/>
          <c:y val="4.5086705202312151E-2"/>
          <c:w val="0.86178534748373847"/>
          <c:h val="0.8260579855263756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0</c:f>
              <c:strCache>
                <c:ptCount val="1"/>
                <c:pt idx="0">
                  <c:v>WT BMMs 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20:$H$20</c:f>
                <c:numCache>
                  <c:formatCode>General</c:formatCode>
                  <c:ptCount val="3"/>
                  <c:pt idx="0">
                    <c:v>0.11347062203728804</c:v>
                  </c:pt>
                  <c:pt idx="1">
                    <c:v>7.178397150870458E-2</c:v>
                  </c:pt>
                  <c:pt idx="2">
                    <c:v>8.6140823780003026E-2</c:v>
                  </c:pt>
                </c:numCache>
              </c:numRef>
            </c:plus>
            <c:minus>
              <c:numRef>
                <c:f>Sheet1!$F$20:$H$20</c:f>
                <c:numCache>
                  <c:formatCode>General</c:formatCode>
                  <c:ptCount val="3"/>
                  <c:pt idx="0">
                    <c:v>0.11347062203728804</c:v>
                  </c:pt>
                  <c:pt idx="1">
                    <c:v>7.178397150870458E-2</c:v>
                  </c:pt>
                  <c:pt idx="2">
                    <c:v>8.614082378000302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19:$D$19</c:f>
              <c:numCache>
                <c:formatCode>General</c:formatCode>
                <c:ptCount val="3"/>
                <c:pt idx="0">
                  <c:v>1</c:v>
                </c:pt>
                <c:pt idx="1">
                  <c:v>24</c:v>
                </c:pt>
                <c:pt idx="2">
                  <c:v>72</c:v>
                </c:pt>
              </c:numCache>
            </c:numRef>
          </c:cat>
          <c:val>
            <c:numRef>
              <c:f>Sheet1!$B$20:$D$20</c:f>
              <c:numCache>
                <c:formatCode>General</c:formatCode>
                <c:ptCount val="3"/>
                <c:pt idx="0">
                  <c:v>4.5963123923512699</c:v>
                </c:pt>
                <c:pt idx="1">
                  <c:v>4.8345286297554129</c:v>
                </c:pt>
                <c:pt idx="2">
                  <c:v>5.416933092414484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C31-9549-BF00-69DB7A892171}"/>
            </c:ext>
          </c:extLst>
        </c:ser>
        <c:ser>
          <c:idx val="1"/>
          <c:order val="1"/>
          <c:tx>
            <c:strRef>
              <c:f>Sheet1!$A$21</c:f>
              <c:strCache>
                <c:ptCount val="1"/>
                <c:pt idx="0">
                  <c:v>WT BMMs + Naïve CD4+ T cells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21:$H$21</c:f>
                <c:numCache>
                  <c:formatCode>General</c:formatCode>
                  <c:ptCount val="3"/>
                  <c:pt idx="0">
                    <c:v>6.0360012237087181E-2</c:v>
                  </c:pt>
                  <c:pt idx="1">
                    <c:v>0.14522031030314989</c:v>
                  </c:pt>
                  <c:pt idx="2">
                    <c:v>0.11995592438697462</c:v>
                  </c:pt>
                </c:numCache>
              </c:numRef>
            </c:plus>
            <c:minus>
              <c:numRef>
                <c:f>Sheet1!$F$21:$H$21</c:f>
                <c:numCache>
                  <c:formatCode>General</c:formatCode>
                  <c:ptCount val="3"/>
                  <c:pt idx="0">
                    <c:v>6.0360012237087181E-2</c:v>
                  </c:pt>
                  <c:pt idx="1">
                    <c:v>0.14522031030314989</c:v>
                  </c:pt>
                  <c:pt idx="2">
                    <c:v>0.119955924386974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19:$D$19</c:f>
              <c:numCache>
                <c:formatCode>General</c:formatCode>
                <c:ptCount val="3"/>
                <c:pt idx="0">
                  <c:v>1</c:v>
                </c:pt>
                <c:pt idx="1">
                  <c:v>24</c:v>
                </c:pt>
                <c:pt idx="2">
                  <c:v>72</c:v>
                </c:pt>
              </c:numCache>
            </c:numRef>
          </c:cat>
          <c:val>
            <c:numRef>
              <c:f>Sheet1!$B$21:$D$21</c:f>
              <c:numCache>
                <c:formatCode>General</c:formatCode>
                <c:ptCount val="3"/>
                <c:pt idx="0">
                  <c:v>4.6622601596106401</c:v>
                </c:pt>
                <c:pt idx="1">
                  <c:v>4.7659315651341672</c:v>
                </c:pt>
                <c:pt idx="2">
                  <c:v>5.45269814745365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C31-9549-BF00-69DB7A892171}"/>
            </c:ext>
          </c:extLst>
        </c:ser>
        <c:ser>
          <c:idx val="2"/>
          <c:order val="2"/>
          <c:tx>
            <c:strRef>
              <c:f>Sheet1!$A$22</c:f>
              <c:strCache>
                <c:ptCount val="1"/>
                <c:pt idx="0">
                  <c:v>WT BMMs + Naïve CD8+ T cells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22:$H$22</c:f>
                <c:numCache>
                  <c:formatCode>General</c:formatCode>
                  <c:ptCount val="3"/>
                  <c:pt idx="0">
                    <c:v>8.0120733005548006E-2</c:v>
                  </c:pt>
                  <c:pt idx="1">
                    <c:v>6.2358397938998812E-2</c:v>
                  </c:pt>
                  <c:pt idx="2">
                    <c:v>7.8620667621583623E-2</c:v>
                  </c:pt>
                </c:numCache>
              </c:numRef>
            </c:plus>
            <c:minus>
              <c:numRef>
                <c:f>Sheet1!$F$22:$H$22</c:f>
                <c:numCache>
                  <c:formatCode>General</c:formatCode>
                  <c:ptCount val="3"/>
                  <c:pt idx="0">
                    <c:v>8.0120733005548006E-2</c:v>
                  </c:pt>
                  <c:pt idx="1">
                    <c:v>6.2358397938998812E-2</c:v>
                  </c:pt>
                  <c:pt idx="2">
                    <c:v>7.862066762158362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B$19:$D$19</c:f>
              <c:numCache>
                <c:formatCode>General</c:formatCode>
                <c:ptCount val="3"/>
                <c:pt idx="0">
                  <c:v>1</c:v>
                </c:pt>
                <c:pt idx="1">
                  <c:v>24</c:v>
                </c:pt>
                <c:pt idx="2">
                  <c:v>72</c:v>
                </c:pt>
              </c:numCache>
            </c:numRef>
          </c:cat>
          <c:val>
            <c:numRef>
              <c:f>Sheet1!$B$22:$D$22</c:f>
              <c:numCache>
                <c:formatCode>General</c:formatCode>
                <c:ptCount val="3"/>
                <c:pt idx="0">
                  <c:v>4.5810943674176983</c:v>
                </c:pt>
                <c:pt idx="1">
                  <c:v>4.8874275822438511</c:v>
                </c:pt>
                <c:pt idx="2">
                  <c:v>5.36321820710130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C31-9549-BF00-69DB7A8921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33981184"/>
        <c:axId val="633985104"/>
      </c:barChart>
      <c:catAx>
        <c:axId val="633981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33985104"/>
        <c:crosses val="autoZero"/>
        <c:auto val="1"/>
        <c:lblAlgn val="ctr"/>
        <c:lblOffset val="100"/>
        <c:noMultiLvlLbl val="0"/>
      </c:catAx>
      <c:valAx>
        <c:axId val="633985104"/>
        <c:scaling>
          <c:orientation val="minMax"/>
          <c:max val="7"/>
          <c:min val="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3398118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0384538797443328"/>
          <c:y val="6.0129756591358753E-2"/>
          <c:w val="0.89615461202556679"/>
          <c:h val="0.2098205297789494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524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81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3067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8420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2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340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041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37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019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761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331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026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="" xmlns:a16="http://schemas.microsoft.com/office/drawing/2014/main" id="{A2CF584D-201E-9945-BD29-09F05E3B3F26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1312992" y="2489176"/>
          <a:ext cx="1989992" cy="16157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332008D7-B187-754D-91C7-9A3C10F8DF9C}"/>
              </a:ext>
            </a:extLst>
          </p:cNvPr>
          <p:cNvSpPr txBox="1"/>
          <p:nvPr/>
        </p:nvSpPr>
        <p:spPr>
          <a:xfrm rot="16200000">
            <a:off x="704786" y="3109501"/>
            <a:ext cx="995785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23" dirty="0"/>
              <a:t>CFU (Log</a:t>
            </a:r>
            <a:r>
              <a:rPr lang="en-US" sz="923" baseline="-25000" dirty="0"/>
              <a:t>10</a:t>
            </a:r>
            <a:r>
              <a:rPr lang="en-US" sz="923" dirty="0"/>
              <a:t>) /wel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5F508AF5-EA30-CE41-983B-04482AFECFFC}"/>
              </a:ext>
            </a:extLst>
          </p:cNvPr>
          <p:cNvSpPr txBox="1"/>
          <p:nvPr/>
        </p:nvSpPr>
        <p:spPr>
          <a:xfrm>
            <a:off x="1705717" y="4045609"/>
            <a:ext cx="1393330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23" dirty="0"/>
              <a:t>Time after Coculture (</a:t>
            </a:r>
            <a:r>
              <a:rPr lang="en-US" sz="923" dirty="0" err="1"/>
              <a:t>Hr</a:t>
            </a:r>
            <a:r>
              <a:rPr lang="en-US" sz="923" dirty="0"/>
              <a:t>)</a:t>
            </a:r>
          </a:p>
        </p:txBody>
      </p:sp>
      <p:graphicFrame>
        <p:nvGraphicFramePr>
          <p:cNvPr id="8" name="Chart 7">
            <a:extLst>
              <a:ext uri="{FF2B5EF4-FFF2-40B4-BE49-F238E27FC236}">
                <a16:creationId xmlns="" xmlns:a16="http://schemas.microsoft.com/office/drawing/2014/main" id="{22D040D2-1C23-7B4A-874C-2796B55CE863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1343853" y="400435"/>
          <a:ext cx="1293273" cy="1597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22A1C88B-F6E7-9440-9683-64460A494DE7}"/>
              </a:ext>
            </a:extLst>
          </p:cNvPr>
          <p:cNvSpPr txBox="1"/>
          <p:nvPr/>
        </p:nvSpPr>
        <p:spPr>
          <a:xfrm>
            <a:off x="980405" y="258041"/>
            <a:ext cx="293670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77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3C475CE9-47C0-A649-ACB5-8A4C73824649}"/>
              </a:ext>
            </a:extLst>
          </p:cNvPr>
          <p:cNvSpPr txBox="1"/>
          <p:nvPr/>
        </p:nvSpPr>
        <p:spPr>
          <a:xfrm>
            <a:off x="980405" y="2336246"/>
            <a:ext cx="285656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77" dirty="0"/>
              <a:t>C</a:t>
            </a:r>
          </a:p>
        </p:txBody>
      </p:sp>
      <p:graphicFrame>
        <p:nvGraphicFramePr>
          <p:cNvPr id="12" name="Chart 11">
            <a:extLst>
              <a:ext uri="{FF2B5EF4-FFF2-40B4-BE49-F238E27FC236}">
                <a16:creationId xmlns="" xmlns:a16="http://schemas.microsoft.com/office/drawing/2014/main" id="{477871DD-44B9-A64A-A43A-AD04905AD2A6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3153092" y="421376"/>
          <a:ext cx="2543345" cy="15612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46958B42-F9D4-8C47-A175-D65E8D1D925B}"/>
              </a:ext>
            </a:extLst>
          </p:cNvPr>
          <p:cNvSpPr txBox="1"/>
          <p:nvPr/>
        </p:nvSpPr>
        <p:spPr>
          <a:xfrm rot="16200000">
            <a:off x="704786" y="1073193"/>
            <a:ext cx="995785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23" dirty="0"/>
              <a:t>CFU (Log</a:t>
            </a:r>
            <a:r>
              <a:rPr lang="en-US" sz="923" baseline="-25000" dirty="0"/>
              <a:t>10</a:t>
            </a:r>
            <a:r>
              <a:rPr lang="en-US" sz="923" dirty="0"/>
              <a:t>) /wel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926A64E8-8D9F-B04E-8593-43AFC9207162}"/>
              </a:ext>
            </a:extLst>
          </p:cNvPr>
          <p:cNvSpPr txBox="1"/>
          <p:nvPr/>
        </p:nvSpPr>
        <p:spPr>
          <a:xfrm>
            <a:off x="1435504" y="1932705"/>
            <a:ext cx="1340432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23" dirty="0"/>
              <a:t>Time post-infection (</a:t>
            </a:r>
            <a:r>
              <a:rPr lang="en-US" sz="923" dirty="0" err="1"/>
              <a:t>Hr</a:t>
            </a:r>
            <a:r>
              <a:rPr lang="en-US" sz="923" dirty="0"/>
              <a:t>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C4C19B69-4182-FF4B-B55E-E15C2BDDB0EA}"/>
              </a:ext>
            </a:extLst>
          </p:cNvPr>
          <p:cNvSpPr txBox="1"/>
          <p:nvPr/>
        </p:nvSpPr>
        <p:spPr>
          <a:xfrm rot="16200000">
            <a:off x="2559678" y="1090063"/>
            <a:ext cx="995785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23" dirty="0"/>
              <a:t>CFU (Log</a:t>
            </a:r>
            <a:r>
              <a:rPr lang="en-US" sz="923" baseline="-25000" dirty="0"/>
              <a:t>10</a:t>
            </a:r>
            <a:r>
              <a:rPr lang="en-US" sz="923" dirty="0"/>
              <a:t>) /wel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67FE2B44-6274-754B-88CD-70C8093B880D}"/>
              </a:ext>
            </a:extLst>
          </p:cNvPr>
          <p:cNvSpPr txBox="1"/>
          <p:nvPr/>
        </p:nvSpPr>
        <p:spPr>
          <a:xfrm>
            <a:off x="3808721" y="1922837"/>
            <a:ext cx="1340432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23" dirty="0"/>
              <a:t>Time post-infection (</a:t>
            </a:r>
            <a:r>
              <a:rPr lang="en-US" sz="923" dirty="0" err="1"/>
              <a:t>Hr</a:t>
            </a:r>
            <a:r>
              <a:rPr lang="en-US" sz="923" dirty="0"/>
              <a:t>)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="" xmlns:a16="http://schemas.microsoft.com/office/drawing/2014/main" id="{44F5E38D-A7F4-4E42-B0AD-85582CFEFA45}"/>
              </a:ext>
            </a:extLst>
          </p:cNvPr>
          <p:cNvSpPr/>
          <p:nvPr/>
        </p:nvSpPr>
        <p:spPr>
          <a:xfrm>
            <a:off x="501706" y="4780080"/>
            <a:ext cx="5833751" cy="18119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16" b="1" dirty="0"/>
              <a:t>S3 Fig. </a:t>
            </a:r>
            <a:r>
              <a:rPr lang="en-US" sz="1016" b="1" i="1" dirty="0" err="1"/>
              <a:t>M.avium</a:t>
            </a:r>
            <a:r>
              <a:rPr lang="en-US" sz="1016" b="1" i="1" dirty="0"/>
              <a:t> </a:t>
            </a:r>
            <a:r>
              <a:rPr lang="en-US" sz="1016" b="1" dirty="0"/>
              <a:t>burden in BMMs or BMMs cocultured with CD4</a:t>
            </a:r>
            <a:r>
              <a:rPr lang="en-US" sz="1016" b="1" baseline="30000" dirty="0"/>
              <a:t>+</a:t>
            </a:r>
            <a:r>
              <a:rPr lang="en-US" sz="1016" b="1" dirty="0"/>
              <a:t>/CD8</a:t>
            </a:r>
            <a:r>
              <a:rPr lang="en-US" sz="1016" b="1" baseline="30000" dirty="0"/>
              <a:t>+ </a:t>
            </a:r>
            <a:r>
              <a:rPr lang="en-US" sz="1016" b="1" dirty="0"/>
              <a:t>T cells.  </a:t>
            </a:r>
          </a:p>
          <a:p>
            <a:pPr marL="211008" indent="-211008">
              <a:buAutoNum type="alphaUcParenR"/>
            </a:pPr>
            <a:r>
              <a:rPr lang="en-US" sz="1016" i="1" dirty="0" err="1"/>
              <a:t>M.avium</a:t>
            </a:r>
            <a:r>
              <a:rPr lang="en-US" sz="1016" i="1" dirty="0"/>
              <a:t> </a:t>
            </a:r>
            <a:r>
              <a:rPr lang="en-US" sz="1016" dirty="0"/>
              <a:t>burden in WT and </a:t>
            </a:r>
            <a:r>
              <a:rPr lang="en-US" sz="1016" i="1" dirty="0"/>
              <a:t>Mavs</a:t>
            </a:r>
            <a:r>
              <a:rPr lang="en-US" sz="1016" i="1" baseline="30000" dirty="0"/>
              <a:t>-/- </a:t>
            </a:r>
            <a:r>
              <a:rPr lang="en-US" sz="1016" dirty="0"/>
              <a:t>BMMs at 1, 24 and 72 </a:t>
            </a:r>
            <a:r>
              <a:rPr lang="en-US" sz="1016" dirty="0" err="1"/>
              <a:t>hr</a:t>
            </a:r>
            <a:r>
              <a:rPr lang="en-US" sz="1016" dirty="0"/>
              <a:t> post infection. </a:t>
            </a:r>
          </a:p>
          <a:p>
            <a:pPr marL="211008" indent="-211008">
              <a:buAutoNum type="alphaUcParenR"/>
            </a:pPr>
            <a:r>
              <a:rPr lang="en-US" sz="1016" i="1" dirty="0" err="1"/>
              <a:t>M.avium</a:t>
            </a:r>
            <a:r>
              <a:rPr lang="en-US" sz="1016" i="1" dirty="0"/>
              <a:t> </a:t>
            </a:r>
            <a:r>
              <a:rPr lang="en-US" sz="1016" dirty="0"/>
              <a:t>burden in mouse BMMs pretreated with negative control siRNA or RIG-I-, TBK1-, IRF3-, or IRF7-specific siRNA.</a:t>
            </a:r>
          </a:p>
          <a:p>
            <a:pPr marL="211008" indent="-211008">
              <a:buAutoNum type="alphaUcParenR"/>
            </a:pPr>
            <a:r>
              <a:rPr lang="en-US" sz="1016" i="1" dirty="0" err="1"/>
              <a:t>M.avium</a:t>
            </a:r>
            <a:r>
              <a:rPr lang="en-US" sz="1016" i="1" dirty="0"/>
              <a:t> </a:t>
            </a:r>
            <a:r>
              <a:rPr lang="en-US" sz="1016" dirty="0"/>
              <a:t>burden in WT and </a:t>
            </a:r>
            <a:r>
              <a:rPr lang="en-US" sz="1016" i="1" dirty="0"/>
              <a:t>Mavs</a:t>
            </a:r>
            <a:r>
              <a:rPr lang="en-US" sz="1016" i="1" baseline="30000" dirty="0"/>
              <a:t>-/- </a:t>
            </a:r>
            <a:r>
              <a:rPr lang="en-US" sz="1016" dirty="0"/>
              <a:t>BMMs cocultured with/without CD8</a:t>
            </a:r>
            <a:r>
              <a:rPr lang="en-US" sz="1016" baseline="30000" dirty="0"/>
              <a:t>+</a:t>
            </a:r>
            <a:r>
              <a:rPr lang="en-US" sz="1016" dirty="0"/>
              <a:t> T cells isolated from WT </a:t>
            </a:r>
            <a:r>
              <a:rPr lang="en-US" sz="1016" i="1" dirty="0" err="1"/>
              <a:t>M.avium</a:t>
            </a:r>
            <a:r>
              <a:rPr lang="en-US" sz="1016" dirty="0"/>
              <a:t>-infected mice (BMM:T cells = 1:2).</a:t>
            </a:r>
          </a:p>
          <a:p>
            <a:pPr marL="211008" indent="-211008">
              <a:buFontTx/>
              <a:buAutoNum type="alphaUcParenR"/>
            </a:pPr>
            <a:r>
              <a:rPr lang="en-US" sz="1016" i="1" dirty="0" err="1"/>
              <a:t>M.avium</a:t>
            </a:r>
            <a:r>
              <a:rPr lang="en-US" sz="1016" i="1" dirty="0"/>
              <a:t> </a:t>
            </a:r>
            <a:r>
              <a:rPr lang="en-US" sz="1016" dirty="0"/>
              <a:t>burden in WT BMMs cocultured with CD4</a:t>
            </a:r>
            <a:r>
              <a:rPr lang="en-US" sz="1016" baseline="30000" dirty="0"/>
              <a:t>+</a:t>
            </a:r>
            <a:r>
              <a:rPr lang="en-US" sz="1016" dirty="0"/>
              <a:t> or CD8</a:t>
            </a:r>
            <a:r>
              <a:rPr lang="en-US" sz="1016" baseline="30000" dirty="0"/>
              <a:t>+</a:t>
            </a:r>
            <a:r>
              <a:rPr lang="en-US" sz="1016" dirty="0"/>
              <a:t> T cells isolated from naïve WT mice (BMM:T cells = 1:2).</a:t>
            </a:r>
          </a:p>
          <a:p>
            <a:r>
              <a:rPr lang="en-US" sz="1016" dirty="0"/>
              <a:t>Data shown are the mean ±SD (n=3 independent infections per group), and all data are representative of three independent experiments. </a:t>
            </a:r>
            <a:r>
              <a:rPr lang="en-US" sz="1016" dirty="0" err="1"/>
              <a:t>n.s</a:t>
            </a:r>
            <a:r>
              <a:rPr lang="en-US" sz="1016" dirty="0"/>
              <a:t>., not statistically significant; *P &lt; 0.05, **P &lt; 0.01, and ***P &lt; 0.001 by Student’s t-test (two-tailed)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42317EE3-9024-7B4D-8788-5BEB9312F463}"/>
              </a:ext>
            </a:extLst>
          </p:cNvPr>
          <p:cNvSpPr txBox="1"/>
          <p:nvPr/>
        </p:nvSpPr>
        <p:spPr>
          <a:xfrm>
            <a:off x="2805312" y="258041"/>
            <a:ext cx="287258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77" dirty="0"/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F7E263AA-5A08-464D-98CE-5FDE42774BD7}"/>
              </a:ext>
            </a:extLst>
          </p:cNvPr>
          <p:cNvSpPr txBox="1"/>
          <p:nvPr/>
        </p:nvSpPr>
        <p:spPr>
          <a:xfrm>
            <a:off x="3267739" y="2357652"/>
            <a:ext cx="301686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77" dirty="0"/>
              <a:t>D</a:t>
            </a:r>
          </a:p>
        </p:txBody>
      </p:sp>
      <p:graphicFrame>
        <p:nvGraphicFramePr>
          <p:cNvPr id="23" name="Chart 22">
            <a:extLst>
              <a:ext uri="{FF2B5EF4-FFF2-40B4-BE49-F238E27FC236}">
                <a16:creationId xmlns="" xmlns:a16="http://schemas.microsoft.com/office/drawing/2014/main" id="{A2CF584D-201E-9945-BD29-09F05E3B3F26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3646681" y="2491240"/>
          <a:ext cx="1645648" cy="16048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7A77E742-3543-CB4E-ABC6-0361D33CB258}"/>
              </a:ext>
            </a:extLst>
          </p:cNvPr>
          <p:cNvSpPr txBox="1"/>
          <p:nvPr/>
        </p:nvSpPr>
        <p:spPr>
          <a:xfrm rot="16200000">
            <a:off x="3090934" y="3118437"/>
            <a:ext cx="995785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23" dirty="0"/>
              <a:t>CFU (Log</a:t>
            </a:r>
            <a:r>
              <a:rPr lang="en-US" sz="923" baseline="-25000" dirty="0"/>
              <a:t>10</a:t>
            </a:r>
            <a:r>
              <a:rPr lang="en-US" sz="923" dirty="0"/>
              <a:t>) /wel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1337573F-9810-3246-A13C-4548366619F3}"/>
              </a:ext>
            </a:extLst>
          </p:cNvPr>
          <p:cNvSpPr txBox="1"/>
          <p:nvPr/>
        </p:nvSpPr>
        <p:spPr>
          <a:xfrm>
            <a:off x="3876247" y="4045609"/>
            <a:ext cx="1393330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23" dirty="0"/>
              <a:t>Time after Coculture (</a:t>
            </a:r>
            <a:r>
              <a:rPr lang="en-US" sz="923" dirty="0" err="1"/>
              <a:t>Hr</a:t>
            </a:r>
            <a:r>
              <a:rPr lang="en-US" sz="923" dirty="0"/>
              <a:t>)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="" xmlns:a16="http://schemas.microsoft.com/office/drawing/2014/main" id="{76379E61-A626-054C-8905-A06C806E2B14}"/>
              </a:ext>
            </a:extLst>
          </p:cNvPr>
          <p:cNvGrpSpPr/>
          <p:nvPr/>
        </p:nvGrpSpPr>
        <p:grpSpPr>
          <a:xfrm>
            <a:off x="4809082" y="2968086"/>
            <a:ext cx="319318" cy="206082"/>
            <a:chOff x="1013851" y="5512837"/>
            <a:chExt cx="345929" cy="223255"/>
          </a:xfrm>
        </p:grpSpPr>
        <p:sp>
          <p:nvSpPr>
            <p:cNvPr id="28" name="TextBox 27">
              <a:extLst>
                <a:ext uri="{FF2B5EF4-FFF2-40B4-BE49-F238E27FC236}">
                  <a16:creationId xmlns="" xmlns:a16="http://schemas.microsoft.com/office/drawing/2014/main" id="{7F2DB443-2F3A-474C-AB3F-D2E841506BCC}"/>
                </a:ext>
              </a:extLst>
            </p:cNvPr>
            <p:cNvSpPr txBox="1"/>
            <p:nvPr/>
          </p:nvSpPr>
          <p:spPr>
            <a:xfrm>
              <a:off x="1013851" y="5512837"/>
              <a:ext cx="345929" cy="22325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sz="739" dirty="0" err="1"/>
                <a:t>n.s</a:t>
              </a:r>
              <a:r>
                <a:rPr lang="en-US" sz="739" dirty="0"/>
                <a:t>.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="" xmlns:a16="http://schemas.microsoft.com/office/drawing/2014/main" id="{58C1B97D-5278-1446-9D6D-430EBA5CA474}"/>
                </a:ext>
              </a:extLst>
            </p:cNvPr>
            <p:cNvCxnSpPr/>
            <p:nvPr/>
          </p:nvCxnSpPr>
          <p:spPr>
            <a:xfrm>
              <a:off x="1067670" y="5698687"/>
              <a:ext cx="228600" cy="0"/>
            </a:xfrm>
            <a:prstGeom prst="line">
              <a:avLst/>
            </a:prstGeom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oup 29">
            <a:extLst>
              <a:ext uri="{FF2B5EF4-FFF2-40B4-BE49-F238E27FC236}">
                <a16:creationId xmlns="" xmlns:a16="http://schemas.microsoft.com/office/drawing/2014/main" id="{81EA61E6-45DD-2340-B8EA-808CC9227D18}"/>
              </a:ext>
            </a:extLst>
          </p:cNvPr>
          <p:cNvGrpSpPr/>
          <p:nvPr/>
        </p:nvGrpSpPr>
        <p:grpSpPr>
          <a:xfrm>
            <a:off x="4855570" y="2845681"/>
            <a:ext cx="441585" cy="206082"/>
            <a:chOff x="864462" y="5478969"/>
            <a:chExt cx="478385" cy="223255"/>
          </a:xfrm>
        </p:grpSpPr>
        <p:sp>
          <p:nvSpPr>
            <p:cNvPr id="31" name="TextBox 30">
              <a:extLst>
                <a:ext uri="{FF2B5EF4-FFF2-40B4-BE49-F238E27FC236}">
                  <a16:creationId xmlns="" xmlns:a16="http://schemas.microsoft.com/office/drawing/2014/main" id="{080CA1BA-3272-3043-A854-93EB8A21AD93}"/>
                </a:ext>
              </a:extLst>
            </p:cNvPr>
            <p:cNvSpPr txBox="1"/>
            <p:nvPr/>
          </p:nvSpPr>
          <p:spPr>
            <a:xfrm>
              <a:off x="996918" y="5478969"/>
              <a:ext cx="345929" cy="22325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sz="739" dirty="0" err="1"/>
                <a:t>n.s</a:t>
              </a:r>
              <a:r>
                <a:rPr lang="en-US" sz="739" dirty="0"/>
                <a:t>.</a:t>
              </a: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="" xmlns:a16="http://schemas.microsoft.com/office/drawing/2014/main" id="{9C5558AB-0884-DB4F-8621-A50D5757456D}"/>
                </a:ext>
              </a:extLst>
            </p:cNvPr>
            <p:cNvCxnSpPr/>
            <p:nvPr/>
          </p:nvCxnSpPr>
          <p:spPr>
            <a:xfrm>
              <a:off x="864462" y="5664819"/>
              <a:ext cx="365760" cy="0"/>
            </a:xfrm>
            <a:prstGeom prst="line">
              <a:avLst/>
            </a:prstGeom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oup 32">
            <a:extLst>
              <a:ext uri="{FF2B5EF4-FFF2-40B4-BE49-F238E27FC236}">
                <a16:creationId xmlns="" xmlns:a16="http://schemas.microsoft.com/office/drawing/2014/main" id="{4CC7A433-4F6F-F347-B6B1-2DE17D1F0DD2}"/>
              </a:ext>
            </a:extLst>
          </p:cNvPr>
          <p:cNvGrpSpPr/>
          <p:nvPr/>
        </p:nvGrpSpPr>
        <p:grpSpPr>
          <a:xfrm>
            <a:off x="1939850" y="1061521"/>
            <a:ext cx="319318" cy="206082"/>
            <a:chOff x="1013851" y="5512837"/>
            <a:chExt cx="345929" cy="223255"/>
          </a:xfrm>
        </p:grpSpPr>
        <p:sp>
          <p:nvSpPr>
            <p:cNvPr id="34" name="TextBox 33">
              <a:extLst>
                <a:ext uri="{FF2B5EF4-FFF2-40B4-BE49-F238E27FC236}">
                  <a16:creationId xmlns="" xmlns:a16="http://schemas.microsoft.com/office/drawing/2014/main" id="{38B72297-276C-3842-8ED2-B5346ADE71A9}"/>
                </a:ext>
              </a:extLst>
            </p:cNvPr>
            <p:cNvSpPr txBox="1"/>
            <p:nvPr/>
          </p:nvSpPr>
          <p:spPr>
            <a:xfrm>
              <a:off x="1013851" y="5512837"/>
              <a:ext cx="345929" cy="22325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sz="739" dirty="0" err="1"/>
                <a:t>n.s</a:t>
              </a:r>
              <a:r>
                <a:rPr lang="en-US" sz="739" dirty="0"/>
                <a:t>.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="" xmlns:a16="http://schemas.microsoft.com/office/drawing/2014/main" id="{F54A2B1E-AA5D-B644-8C37-94278DAA2E24}"/>
                </a:ext>
              </a:extLst>
            </p:cNvPr>
            <p:cNvCxnSpPr/>
            <p:nvPr/>
          </p:nvCxnSpPr>
          <p:spPr>
            <a:xfrm>
              <a:off x="1067670" y="5698687"/>
              <a:ext cx="228600" cy="0"/>
            </a:xfrm>
            <a:prstGeom prst="line">
              <a:avLst/>
            </a:prstGeom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35">
            <a:extLst>
              <a:ext uri="{FF2B5EF4-FFF2-40B4-BE49-F238E27FC236}">
                <a16:creationId xmlns="" xmlns:a16="http://schemas.microsoft.com/office/drawing/2014/main" id="{7AFA6C93-8FCD-9648-88E6-9208258BC4EB}"/>
              </a:ext>
            </a:extLst>
          </p:cNvPr>
          <p:cNvGrpSpPr/>
          <p:nvPr/>
        </p:nvGrpSpPr>
        <p:grpSpPr>
          <a:xfrm>
            <a:off x="2313740" y="835621"/>
            <a:ext cx="231154" cy="206082"/>
            <a:chOff x="1061607" y="5553181"/>
            <a:chExt cx="250417" cy="223255"/>
          </a:xfrm>
        </p:grpSpPr>
        <p:sp>
          <p:nvSpPr>
            <p:cNvPr id="37" name="TextBox 36">
              <a:extLst>
                <a:ext uri="{FF2B5EF4-FFF2-40B4-BE49-F238E27FC236}">
                  <a16:creationId xmlns="" xmlns:a16="http://schemas.microsoft.com/office/drawing/2014/main" id="{5A685A78-9787-6443-BFAF-22B5A287107E}"/>
                </a:ext>
              </a:extLst>
            </p:cNvPr>
            <p:cNvSpPr txBox="1"/>
            <p:nvPr/>
          </p:nvSpPr>
          <p:spPr>
            <a:xfrm>
              <a:off x="1061607" y="5553181"/>
              <a:ext cx="250417" cy="22325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sz="739" dirty="0"/>
                <a:t>*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="" xmlns:a16="http://schemas.microsoft.com/office/drawing/2014/main" id="{48385534-53C8-3E4D-9034-F2AB86C8A656}"/>
                </a:ext>
              </a:extLst>
            </p:cNvPr>
            <p:cNvCxnSpPr/>
            <p:nvPr/>
          </p:nvCxnSpPr>
          <p:spPr>
            <a:xfrm>
              <a:off x="1067670" y="5698687"/>
              <a:ext cx="228600" cy="0"/>
            </a:xfrm>
            <a:prstGeom prst="line">
              <a:avLst/>
            </a:prstGeom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>
            <a:extLst>
              <a:ext uri="{FF2B5EF4-FFF2-40B4-BE49-F238E27FC236}">
                <a16:creationId xmlns="" xmlns:a16="http://schemas.microsoft.com/office/drawing/2014/main" id="{7CF56433-E6B8-854C-9267-03B2C5EEFA58}"/>
              </a:ext>
            </a:extLst>
          </p:cNvPr>
          <p:cNvGrpSpPr/>
          <p:nvPr/>
        </p:nvGrpSpPr>
        <p:grpSpPr>
          <a:xfrm>
            <a:off x="4862201" y="974914"/>
            <a:ext cx="277640" cy="206082"/>
            <a:chOff x="1036428" y="5559905"/>
            <a:chExt cx="300775" cy="223255"/>
          </a:xfrm>
        </p:grpSpPr>
        <p:sp>
          <p:nvSpPr>
            <p:cNvPr id="40" name="TextBox 39">
              <a:extLst>
                <a:ext uri="{FF2B5EF4-FFF2-40B4-BE49-F238E27FC236}">
                  <a16:creationId xmlns="" xmlns:a16="http://schemas.microsoft.com/office/drawing/2014/main" id="{C796480C-797C-1748-BFC9-DA50418B9AC5}"/>
                </a:ext>
              </a:extLst>
            </p:cNvPr>
            <p:cNvSpPr txBox="1"/>
            <p:nvPr/>
          </p:nvSpPr>
          <p:spPr>
            <a:xfrm>
              <a:off x="1036428" y="5559905"/>
              <a:ext cx="300775" cy="22325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sz="739" dirty="0"/>
                <a:t>**</a:t>
              </a: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="" xmlns:a16="http://schemas.microsoft.com/office/drawing/2014/main" id="{34858458-B5F1-2E44-B328-5EFD934AA4B4}"/>
                </a:ext>
              </a:extLst>
            </p:cNvPr>
            <p:cNvCxnSpPr/>
            <p:nvPr/>
          </p:nvCxnSpPr>
          <p:spPr>
            <a:xfrm>
              <a:off x="1067670" y="5698687"/>
              <a:ext cx="228600" cy="0"/>
            </a:xfrm>
            <a:prstGeom prst="line">
              <a:avLst/>
            </a:prstGeom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41">
            <a:extLst>
              <a:ext uri="{FF2B5EF4-FFF2-40B4-BE49-F238E27FC236}">
                <a16:creationId xmlns="" xmlns:a16="http://schemas.microsoft.com/office/drawing/2014/main" id="{912E7989-AC5C-4648-B59E-8F76B27763D9}"/>
              </a:ext>
            </a:extLst>
          </p:cNvPr>
          <p:cNvGrpSpPr/>
          <p:nvPr/>
        </p:nvGrpSpPr>
        <p:grpSpPr>
          <a:xfrm>
            <a:off x="4896003" y="843557"/>
            <a:ext cx="424170" cy="206082"/>
            <a:chOff x="1067670" y="5553181"/>
            <a:chExt cx="459518" cy="223255"/>
          </a:xfrm>
        </p:grpSpPr>
        <p:sp>
          <p:nvSpPr>
            <p:cNvPr id="43" name="TextBox 42">
              <a:extLst>
                <a:ext uri="{FF2B5EF4-FFF2-40B4-BE49-F238E27FC236}">
                  <a16:creationId xmlns="" xmlns:a16="http://schemas.microsoft.com/office/drawing/2014/main" id="{94A5047D-2932-DD4C-9F3D-FDF6D28E6508}"/>
                </a:ext>
              </a:extLst>
            </p:cNvPr>
            <p:cNvSpPr txBox="1"/>
            <p:nvPr/>
          </p:nvSpPr>
          <p:spPr>
            <a:xfrm>
              <a:off x="1276771" y="5553181"/>
              <a:ext cx="250417" cy="22325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sz="739" dirty="0"/>
                <a:t>*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="" xmlns:a16="http://schemas.microsoft.com/office/drawing/2014/main" id="{95BE4A6A-A7F3-A046-8F04-936BFA207CE9}"/>
                </a:ext>
              </a:extLst>
            </p:cNvPr>
            <p:cNvCxnSpPr/>
            <p:nvPr/>
          </p:nvCxnSpPr>
          <p:spPr>
            <a:xfrm>
              <a:off x="1067670" y="5698687"/>
              <a:ext cx="365760" cy="0"/>
            </a:xfrm>
            <a:prstGeom prst="line">
              <a:avLst/>
            </a:prstGeom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oup 44">
            <a:extLst>
              <a:ext uri="{FF2B5EF4-FFF2-40B4-BE49-F238E27FC236}">
                <a16:creationId xmlns="" xmlns:a16="http://schemas.microsoft.com/office/drawing/2014/main" id="{66C81A67-8567-A04F-8594-11FC6A853280}"/>
              </a:ext>
            </a:extLst>
          </p:cNvPr>
          <p:cNvGrpSpPr/>
          <p:nvPr/>
        </p:nvGrpSpPr>
        <p:grpSpPr>
          <a:xfrm>
            <a:off x="4892785" y="729725"/>
            <a:ext cx="585537" cy="206082"/>
            <a:chOff x="1067670" y="5553181"/>
            <a:chExt cx="634332" cy="223255"/>
          </a:xfrm>
        </p:grpSpPr>
        <p:sp>
          <p:nvSpPr>
            <p:cNvPr id="46" name="TextBox 45">
              <a:extLst>
                <a:ext uri="{FF2B5EF4-FFF2-40B4-BE49-F238E27FC236}">
                  <a16:creationId xmlns="" xmlns:a16="http://schemas.microsoft.com/office/drawing/2014/main" id="{15B11342-4AAD-A748-A566-6F86BD0D15C5}"/>
                </a:ext>
              </a:extLst>
            </p:cNvPr>
            <p:cNvSpPr txBox="1"/>
            <p:nvPr/>
          </p:nvSpPr>
          <p:spPr>
            <a:xfrm>
              <a:off x="1451585" y="5553181"/>
              <a:ext cx="250417" cy="22325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sz="739" dirty="0"/>
                <a:t>*</a:t>
              </a: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="" xmlns:a16="http://schemas.microsoft.com/office/drawing/2014/main" id="{CF536413-20BF-C246-909D-74D48B62F4A3}"/>
                </a:ext>
              </a:extLst>
            </p:cNvPr>
            <p:cNvCxnSpPr/>
            <p:nvPr/>
          </p:nvCxnSpPr>
          <p:spPr>
            <a:xfrm>
              <a:off x="1067670" y="5698687"/>
              <a:ext cx="548640" cy="0"/>
            </a:xfrm>
            <a:prstGeom prst="line">
              <a:avLst/>
            </a:prstGeom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" name="Group 47">
            <a:extLst>
              <a:ext uri="{FF2B5EF4-FFF2-40B4-BE49-F238E27FC236}">
                <a16:creationId xmlns="" xmlns:a16="http://schemas.microsoft.com/office/drawing/2014/main" id="{3B1ABD6A-10B6-3F45-8D69-CB8E279F1EE7}"/>
              </a:ext>
            </a:extLst>
          </p:cNvPr>
          <p:cNvGrpSpPr/>
          <p:nvPr/>
        </p:nvGrpSpPr>
        <p:grpSpPr>
          <a:xfrm>
            <a:off x="4898807" y="596551"/>
            <a:ext cx="689461" cy="206082"/>
            <a:chOff x="1067670" y="5553181"/>
            <a:chExt cx="746915" cy="223255"/>
          </a:xfrm>
        </p:grpSpPr>
        <p:sp>
          <p:nvSpPr>
            <p:cNvPr id="49" name="TextBox 48">
              <a:extLst>
                <a:ext uri="{FF2B5EF4-FFF2-40B4-BE49-F238E27FC236}">
                  <a16:creationId xmlns="" xmlns:a16="http://schemas.microsoft.com/office/drawing/2014/main" id="{1EB492B9-BD93-9F4B-8D30-478E2C2ACDF8}"/>
                </a:ext>
              </a:extLst>
            </p:cNvPr>
            <p:cNvSpPr txBox="1"/>
            <p:nvPr/>
          </p:nvSpPr>
          <p:spPr>
            <a:xfrm>
              <a:off x="1513809" y="5553181"/>
              <a:ext cx="300776" cy="22325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sz="739" dirty="0"/>
                <a:t>**</a:t>
              </a:r>
            </a:p>
          </p:txBody>
        </p:sp>
        <p:cxnSp>
          <p:nvCxnSpPr>
            <p:cNvPr id="50" name="Straight Connector 49">
              <a:extLst>
                <a:ext uri="{FF2B5EF4-FFF2-40B4-BE49-F238E27FC236}">
                  <a16:creationId xmlns="" xmlns:a16="http://schemas.microsoft.com/office/drawing/2014/main" id="{88267937-C984-B240-A9F2-70A58BD28E91}"/>
                </a:ext>
              </a:extLst>
            </p:cNvPr>
            <p:cNvCxnSpPr/>
            <p:nvPr/>
          </p:nvCxnSpPr>
          <p:spPr>
            <a:xfrm>
              <a:off x="1067670" y="5698687"/>
              <a:ext cx="640080" cy="0"/>
            </a:xfrm>
            <a:prstGeom prst="line">
              <a:avLst/>
            </a:prstGeom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" name="Group 50">
            <a:extLst>
              <a:ext uri="{FF2B5EF4-FFF2-40B4-BE49-F238E27FC236}">
                <a16:creationId xmlns="" xmlns:a16="http://schemas.microsoft.com/office/drawing/2014/main" id="{9EA5369F-F3D7-0149-960E-0E6351801583}"/>
              </a:ext>
            </a:extLst>
          </p:cNvPr>
          <p:cNvGrpSpPr/>
          <p:nvPr/>
        </p:nvGrpSpPr>
        <p:grpSpPr>
          <a:xfrm>
            <a:off x="2731493" y="2987745"/>
            <a:ext cx="231154" cy="206082"/>
            <a:chOff x="1061607" y="5553181"/>
            <a:chExt cx="250417" cy="223255"/>
          </a:xfrm>
        </p:grpSpPr>
        <p:sp>
          <p:nvSpPr>
            <p:cNvPr id="52" name="TextBox 51">
              <a:extLst>
                <a:ext uri="{FF2B5EF4-FFF2-40B4-BE49-F238E27FC236}">
                  <a16:creationId xmlns="" xmlns:a16="http://schemas.microsoft.com/office/drawing/2014/main" id="{1FFA865B-D6CC-2F4D-9C0C-A9A6B3EE1EE9}"/>
                </a:ext>
              </a:extLst>
            </p:cNvPr>
            <p:cNvSpPr txBox="1"/>
            <p:nvPr/>
          </p:nvSpPr>
          <p:spPr>
            <a:xfrm>
              <a:off x="1061607" y="5553181"/>
              <a:ext cx="250417" cy="22325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sz="739" dirty="0"/>
                <a:t>*</a:t>
              </a: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="" xmlns:a16="http://schemas.microsoft.com/office/drawing/2014/main" id="{752E47C5-8493-A841-B932-2830A989DC78}"/>
                </a:ext>
              </a:extLst>
            </p:cNvPr>
            <p:cNvCxnSpPr/>
            <p:nvPr/>
          </p:nvCxnSpPr>
          <p:spPr>
            <a:xfrm>
              <a:off x="1067670" y="5698687"/>
              <a:ext cx="228600" cy="0"/>
            </a:xfrm>
            <a:prstGeom prst="line">
              <a:avLst/>
            </a:prstGeom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Group 53">
            <a:extLst>
              <a:ext uri="{FF2B5EF4-FFF2-40B4-BE49-F238E27FC236}">
                <a16:creationId xmlns="" xmlns:a16="http://schemas.microsoft.com/office/drawing/2014/main" id="{37F4E2E0-37F6-1F4F-9CA6-62F7316A4C8C}"/>
              </a:ext>
            </a:extLst>
          </p:cNvPr>
          <p:cNvGrpSpPr/>
          <p:nvPr/>
        </p:nvGrpSpPr>
        <p:grpSpPr>
          <a:xfrm>
            <a:off x="2955521" y="2784021"/>
            <a:ext cx="319318" cy="206082"/>
            <a:chOff x="1013850" y="5510649"/>
            <a:chExt cx="345929" cy="223255"/>
          </a:xfrm>
        </p:grpSpPr>
        <p:sp>
          <p:nvSpPr>
            <p:cNvPr id="55" name="TextBox 54">
              <a:extLst>
                <a:ext uri="{FF2B5EF4-FFF2-40B4-BE49-F238E27FC236}">
                  <a16:creationId xmlns="" xmlns:a16="http://schemas.microsoft.com/office/drawing/2014/main" id="{86B65607-FD69-5240-A3E7-4086B1D66FFF}"/>
                </a:ext>
              </a:extLst>
            </p:cNvPr>
            <p:cNvSpPr txBox="1"/>
            <p:nvPr/>
          </p:nvSpPr>
          <p:spPr>
            <a:xfrm>
              <a:off x="1013850" y="5510649"/>
              <a:ext cx="345929" cy="22325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sz="739" dirty="0" err="1"/>
                <a:t>n.s</a:t>
              </a:r>
              <a:r>
                <a:rPr lang="en-US" sz="739" dirty="0"/>
                <a:t>.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="" xmlns:a16="http://schemas.microsoft.com/office/drawing/2014/main" id="{6B16F606-385C-AF4C-B02E-EF3EF0B80A18}"/>
                </a:ext>
              </a:extLst>
            </p:cNvPr>
            <p:cNvCxnSpPr/>
            <p:nvPr/>
          </p:nvCxnSpPr>
          <p:spPr>
            <a:xfrm>
              <a:off x="1067670" y="5698687"/>
              <a:ext cx="228600" cy="0"/>
            </a:xfrm>
            <a:prstGeom prst="line">
              <a:avLst/>
            </a:prstGeom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328464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22</Words>
  <Application>Microsoft Office PowerPoint</Application>
  <PresentationFormat>Letter Paper (8.5x11 in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Notre Dam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rey Schorey</dc:creator>
  <cp:lastModifiedBy>Jeffrey Schorey</cp:lastModifiedBy>
  <cp:revision>3</cp:revision>
  <dcterms:created xsi:type="dcterms:W3CDTF">2020-04-29T17:59:52Z</dcterms:created>
  <dcterms:modified xsi:type="dcterms:W3CDTF">2020-04-29T18:06:15Z</dcterms:modified>
</cp:coreProperties>
</file>